
<file path=[Content_Types].xml><?xml version="1.0" encoding="utf-8"?>
<Types xmlns="http://schemas.openxmlformats.org/package/2006/content-types">
  <Default Extension="png" ContentType="image/png"/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10"/>
  </p:notesMasterIdLst>
  <p:sldIdLst>
    <p:sldId id="257" r:id="rId2"/>
    <p:sldId id="264" r:id="rId3"/>
    <p:sldId id="263" r:id="rId4"/>
    <p:sldId id="258" r:id="rId5"/>
    <p:sldId id="259" r:id="rId6"/>
    <p:sldId id="260" r:id="rId7"/>
    <p:sldId id="261" r:id="rId8"/>
    <p:sldId id="262" r:id="rId9"/>
  </p:sldIdLst>
  <p:sldSz cx="6858000" cy="9906000" type="A4"/>
  <p:notesSz cx="7099300" cy="102346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1" d="100"/>
          <a:sy n="61" d="100"/>
        </p:scale>
        <p:origin x="2539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6363" cy="513508"/>
          </a:xfrm>
          <a:prstGeom prst="rect">
            <a:avLst/>
          </a:prstGeom>
        </p:spPr>
        <p:txBody>
          <a:bodyPr vert="horz" lIns="99048" tIns="49524" rIns="99048" bIns="49524" rtlCol="0"/>
          <a:lstStyle>
            <a:lvl1pPr algn="l">
              <a:defRPr sz="13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021294" y="0"/>
            <a:ext cx="3076363" cy="513508"/>
          </a:xfrm>
          <a:prstGeom prst="rect">
            <a:avLst/>
          </a:prstGeom>
        </p:spPr>
        <p:txBody>
          <a:bodyPr vert="horz" lIns="99048" tIns="49524" rIns="99048" bIns="49524" rtlCol="0"/>
          <a:lstStyle>
            <a:lvl1pPr algn="r">
              <a:defRPr sz="1300"/>
            </a:lvl1pPr>
          </a:lstStyle>
          <a:p>
            <a:fld id="{86C6A180-EBCC-447B-8831-62635ACCD84A}" type="datetimeFigureOut">
              <a:rPr lang="en-GB" smtClean="0"/>
              <a:t>01/07/2020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54263" y="1279525"/>
            <a:ext cx="2390775" cy="34544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9048" tIns="49524" rIns="99048" bIns="49524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9930" y="4925407"/>
            <a:ext cx="5679440" cy="4029879"/>
          </a:xfrm>
          <a:prstGeom prst="rect">
            <a:avLst/>
          </a:prstGeom>
        </p:spPr>
        <p:txBody>
          <a:bodyPr vert="horz" lIns="99048" tIns="49524" rIns="99048" bIns="49524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721107"/>
            <a:ext cx="3076363" cy="513507"/>
          </a:xfrm>
          <a:prstGeom prst="rect">
            <a:avLst/>
          </a:prstGeom>
        </p:spPr>
        <p:txBody>
          <a:bodyPr vert="horz" lIns="99048" tIns="49524" rIns="99048" bIns="49524" rtlCol="0" anchor="b"/>
          <a:lstStyle>
            <a:lvl1pPr algn="l">
              <a:defRPr sz="13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021294" y="9721107"/>
            <a:ext cx="3076363" cy="513507"/>
          </a:xfrm>
          <a:prstGeom prst="rect">
            <a:avLst/>
          </a:prstGeom>
        </p:spPr>
        <p:txBody>
          <a:bodyPr vert="horz" lIns="99048" tIns="49524" rIns="99048" bIns="49524" rtlCol="0" anchor="b"/>
          <a:lstStyle>
            <a:lvl1pPr algn="r">
              <a:defRPr sz="1300"/>
            </a:lvl1pPr>
          </a:lstStyle>
          <a:p>
            <a:fld id="{8EA73306-1DAC-42EE-A7DB-F22B3FDDE5E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5165568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dirty="0" smtClean="0"/>
              <a:t>Scale</a:t>
            </a:r>
            <a:r>
              <a:rPr lang="en-GB" baseline="0" dirty="0" smtClean="0"/>
              <a:t> bar = 100 um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B78744-000E-47F3-8A2F-49D996465A8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0779276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dirty="0" smtClean="0"/>
              <a:t>Scale</a:t>
            </a:r>
            <a:r>
              <a:rPr lang="en-GB" baseline="0" dirty="0" smtClean="0"/>
              <a:t> bar = 100 um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B78744-000E-47F3-8A2F-49D996465A85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4085576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dirty="0" smtClean="0"/>
              <a:t>Scale</a:t>
            </a:r>
            <a:r>
              <a:rPr lang="en-GB" baseline="0" dirty="0" smtClean="0"/>
              <a:t> bar = 100 um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B78744-000E-47F3-8A2F-49D996465A85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26802967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dirty="0" smtClean="0"/>
              <a:t>Scale</a:t>
            </a:r>
            <a:r>
              <a:rPr lang="en-GB" baseline="0" dirty="0" smtClean="0"/>
              <a:t> bar = 100 um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B78744-000E-47F3-8A2F-49D996465A85}" type="slidenum">
              <a:rPr lang="en-GB" smtClean="0"/>
              <a:t>4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08431777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dirty="0" smtClean="0"/>
              <a:t>Scale bar = 100 um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B78744-000E-47F3-8A2F-49D996465A85}" type="slidenum">
              <a:rPr lang="en-GB" smtClean="0"/>
              <a:t>5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87505752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B78744-000E-47F3-8A2F-49D996465A85}" type="slidenum">
              <a:rPr lang="en-GB" smtClean="0"/>
              <a:t>6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254914045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B78744-000E-47F3-8A2F-49D996465A85}" type="slidenum">
              <a:rPr lang="en-GB" smtClean="0"/>
              <a:t>7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42632677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B78744-000E-47F3-8A2F-49D996465A85}" type="slidenum">
              <a:rPr lang="en-GB" smtClean="0"/>
              <a:t>8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57004557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017E45-216F-477E-B0FA-A8E2294E889E}" type="datetimeFigureOut">
              <a:rPr lang="en-GB" smtClean="0"/>
              <a:t>01/07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6ABAF2-D52A-41E2-8D8F-E2FA9D7657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737051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017E45-216F-477E-B0FA-A8E2294E889E}" type="datetimeFigureOut">
              <a:rPr lang="en-GB" smtClean="0"/>
              <a:t>01/07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6ABAF2-D52A-41E2-8D8F-E2FA9D7657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194606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017E45-216F-477E-B0FA-A8E2294E889E}" type="datetimeFigureOut">
              <a:rPr lang="en-GB" smtClean="0"/>
              <a:t>01/07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6ABAF2-D52A-41E2-8D8F-E2FA9D7657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833683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017E45-216F-477E-B0FA-A8E2294E889E}" type="datetimeFigureOut">
              <a:rPr lang="en-GB" smtClean="0"/>
              <a:t>01/07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6ABAF2-D52A-41E2-8D8F-E2FA9D7657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54022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017E45-216F-477E-B0FA-A8E2294E889E}" type="datetimeFigureOut">
              <a:rPr lang="en-GB" smtClean="0"/>
              <a:t>01/07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6ABAF2-D52A-41E2-8D8F-E2FA9D7657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870616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017E45-216F-477E-B0FA-A8E2294E889E}" type="datetimeFigureOut">
              <a:rPr lang="en-GB" smtClean="0"/>
              <a:t>01/07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6ABAF2-D52A-41E2-8D8F-E2FA9D7657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511185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017E45-216F-477E-B0FA-A8E2294E889E}" type="datetimeFigureOut">
              <a:rPr lang="en-GB" smtClean="0"/>
              <a:t>01/07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6ABAF2-D52A-41E2-8D8F-E2FA9D7657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639546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017E45-216F-477E-B0FA-A8E2294E889E}" type="datetimeFigureOut">
              <a:rPr lang="en-GB" smtClean="0"/>
              <a:t>01/07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6ABAF2-D52A-41E2-8D8F-E2FA9D7657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152945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017E45-216F-477E-B0FA-A8E2294E889E}" type="datetimeFigureOut">
              <a:rPr lang="en-GB" smtClean="0"/>
              <a:t>01/07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6ABAF2-D52A-41E2-8D8F-E2FA9D7657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480704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017E45-216F-477E-B0FA-A8E2294E889E}" type="datetimeFigureOut">
              <a:rPr lang="en-GB" smtClean="0"/>
              <a:t>01/07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6ABAF2-D52A-41E2-8D8F-E2FA9D7657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727496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017E45-216F-477E-B0FA-A8E2294E889E}" type="datetimeFigureOut">
              <a:rPr lang="en-GB" smtClean="0"/>
              <a:t>01/07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6ABAF2-D52A-41E2-8D8F-E2FA9D7657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145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017E45-216F-477E-B0FA-A8E2294E889E}" type="datetimeFigureOut">
              <a:rPr lang="en-GB" smtClean="0"/>
              <a:t>01/07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6ABAF2-D52A-41E2-8D8F-E2FA9D7657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920850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3.jpeg"/><Relationship Id="rId4" Type="http://schemas.openxmlformats.org/officeDocument/2006/relationships/image" Target="../media/image2.jpe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4.tiff"/><Relationship Id="rId7" Type="http://schemas.microsoft.com/office/2007/relationships/hdphoto" Target="../media/hdphoto2.wdp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6.jpeg"/><Relationship Id="rId5" Type="http://schemas.microsoft.com/office/2007/relationships/hdphoto" Target="../media/hdphoto1.wdp"/><Relationship Id="rId4" Type="http://schemas.openxmlformats.org/officeDocument/2006/relationships/image" Target="../media/image5.png"/></Relationships>
</file>

<file path=ppt/slides/_rels/slide5.xml.rels><?xml version="1.0" encoding="UTF-8" standalone="yes"?>
<Relationships xmlns="http://schemas.openxmlformats.org/package/2006/relationships"><Relationship Id="rId8" Type="http://schemas.microsoft.com/office/2007/relationships/hdphoto" Target="../media/hdphoto5.wdp"/><Relationship Id="rId3" Type="http://schemas.openxmlformats.org/officeDocument/2006/relationships/image" Target="../media/image8.png"/><Relationship Id="rId7" Type="http://schemas.openxmlformats.org/officeDocument/2006/relationships/image" Target="../media/image10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6.xml"/><Relationship Id="rId6" Type="http://schemas.microsoft.com/office/2007/relationships/hdphoto" Target="../media/hdphoto4.wdp"/><Relationship Id="rId5" Type="http://schemas.openxmlformats.org/officeDocument/2006/relationships/image" Target="../media/image9.png"/><Relationship Id="rId10" Type="http://schemas.microsoft.com/office/2007/relationships/hdphoto" Target="../media/hdphoto6.wdp"/><Relationship Id="rId4" Type="http://schemas.microsoft.com/office/2007/relationships/hdphoto" Target="../media/hdphoto3.wdp"/><Relationship Id="rId9" Type="http://schemas.openxmlformats.org/officeDocument/2006/relationships/image" Target="../media/image11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emf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5.emf"/><Relationship Id="rId4" Type="http://schemas.openxmlformats.org/officeDocument/2006/relationships/image" Target="../media/image14.em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/>
          <p:cNvSpPr txBox="1"/>
          <p:nvPr/>
        </p:nvSpPr>
        <p:spPr>
          <a:xfrm>
            <a:off x="203407" y="449655"/>
            <a:ext cx="6504281" cy="59093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Immune characterization of pre-clinical murine models of neuroblastoma </a:t>
            </a:r>
            <a:endParaRPr lang="en-US" b="1" dirty="0" smtClean="0"/>
          </a:p>
          <a:p>
            <a:endParaRPr lang="en-US" b="1" dirty="0"/>
          </a:p>
          <a:p>
            <a:r>
              <a:rPr lang="en-US" b="1" i="1" dirty="0" smtClean="0"/>
              <a:t>Supplementary information</a:t>
            </a:r>
            <a:endParaRPr lang="en-GB" i="1" dirty="0"/>
          </a:p>
          <a:p>
            <a:r>
              <a:rPr lang="en-US" b="1" dirty="0"/>
              <a:t> </a:t>
            </a:r>
            <a:endParaRPr lang="en-GB" dirty="0"/>
          </a:p>
          <a:p>
            <a:r>
              <a:rPr lang="en-US" dirty="0"/>
              <a:t>Emily R. Webb</a:t>
            </a:r>
            <a:r>
              <a:rPr lang="en-US" baseline="30000" dirty="0"/>
              <a:t>1,3</a:t>
            </a:r>
            <a:r>
              <a:rPr lang="en-US" dirty="0"/>
              <a:t>, Silvia Lanati</a:t>
            </a:r>
            <a:r>
              <a:rPr lang="en-US" baseline="30000" dirty="0"/>
              <a:t>1</a:t>
            </a:r>
            <a:r>
              <a:rPr lang="en-US" dirty="0"/>
              <a:t>, Carol Wareham</a:t>
            </a:r>
            <a:r>
              <a:rPr lang="en-US" baseline="30000" dirty="0"/>
              <a:t>1</a:t>
            </a:r>
            <a:r>
              <a:rPr lang="en-US" dirty="0"/>
              <a:t>, Alistair Easton</a:t>
            </a:r>
            <a:r>
              <a:rPr lang="en-US" baseline="30000" dirty="0"/>
              <a:t>1,2,4</a:t>
            </a:r>
            <a:r>
              <a:rPr lang="en-US" dirty="0"/>
              <a:t>, Stuart N. Dunn</a:t>
            </a:r>
            <a:r>
              <a:rPr lang="en-US" baseline="30000" dirty="0"/>
              <a:t>1</a:t>
            </a:r>
            <a:r>
              <a:rPr lang="en-US" dirty="0"/>
              <a:t>, Tatyana Inzhelevskaya</a:t>
            </a:r>
            <a:r>
              <a:rPr lang="en-US" baseline="30000" dirty="0"/>
              <a:t>1</a:t>
            </a:r>
            <a:r>
              <a:rPr lang="en-US" dirty="0"/>
              <a:t>, </a:t>
            </a:r>
            <a:r>
              <a:rPr lang="en-US" dirty="0" err="1"/>
              <a:t>Freja</a:t>
            </a:r>
            <a:r>
              <a:rPr lang="en-US" dirty="0"/>
              <a:t> M. Sadler</a:t>
            </a:r>
            <a:r>
              <a:rPr lang="en-US" baseline="30000" dirty="0"/>
              <a:t>1</a:t>
            </a:r>
            <a:r>
              <a:rPr lang="en-US" dirty="0"/>
              <a:t>, Sonya James</a:t>
            </a:r>
            <a:r>
              <a:rPr lang="en-US" baseline="30000" dirty="0"/>
              <a:t>1</a:t>
            </a:r>
            <a:r>
              <a:rPr lang="en-US" dirty="0"/>
              <a:t>, Margaret Ashton-Key</a:t>
            </a:r>
            <a:r>
              <a:rPr lang="en-US" baseline="30000" dirty="0"/>
              <a:t>2</a:t>
            </a:r>
            <a:r>
              <a:rPr lang="en-US" dirty="0"/>
              <a:t>, Mark S. Cragg</a:t>
            </a:r>
            <a:r>
              <a:rPr lang="en-US" baseline="30000" dirty="0"/>
              <a:t>1</a:t>
            </a:r>
            <a:r>
              <a:rPr lang="en-US" dirty="0"/>
              <a:t>, Stephen A. Beers</a:t>
            </a:r>
            <a:r>
              <a:rPr lang="en-US" baseline="30000" dirty="0"/>
              <a:t>1,*</a:t>
            </a:r>
            <a:r>
              <a:rPr lang="en-US" dirty="0"/>
              <a:t>, and Juliet C. Gray</a:t>
            </a:r>
            <a:r>
              <a:rPr lang="en-US" baseline="30000" dirty="0"/>
              <a:t>1,*</a:t>
            </a:r>
            <a:endParaRPr lang="en-GB" dirty="0"/>
          </a:p>
          <a:p>
            <a:r>
              <a:rPr lang="en-US" baseline="30000" dirty="0"/>
              <a:t> </a:t>
            </a:r>
            <a:endParaRPr lang="en-GB" dirty="0"/>
          </a:p>
          <a:p>
            <a:pPr algn="just"/>
            <a:r>
              <a:rPr lang="en-US" baseline="30000" dirty="0"/>
              <a:t>1</a:t>
            </a:r>
            <a:r>
              <a:rPr lang="en-US" dirty="0"/>
              <a:t>Antibody and Vaccine Group, Centre for Cancer Immunology,  University of Southampton Faculty of Medicine,  Southampton General Hospital, Southampton, Hampshire, SO16 6YD, United Kingdom. </a:t>
            </a:r>
            <a:r>
              <a:rPr lang="en-US" baseline="30000" dirty="0"/>
              <a:t>2</a:t>
            </a:r>
            <a:r>
              <a:rPr lang="en-US" dirty="0"/>
              <a:t>Cellular Pathology, University Hospitals Southampton NHS Foundation Trust, Southampton, United Kingdom, SO16 6YD. </a:t>
            </a:r>
            <a:r>
              <a:rPr lang="en-US" baseline="30000" dirty="0"/>
              <a:t>3</a:t>
            </a:r>
            <a:r>
              <a:rPr lang="en-US" dirty="0"/>
              <a:t>Current affiliation: Edinburgh Cancer Research Centre, Institute of Genetics and Molecular Medicine, University of Edinburgh, Western General Hospital, Edinburgh, EH4 2XU, United Kingdom. </a:t>
            </a:r>
            <a:r>
              <a:rPr lang="en-US" baseline="30000" dirty="0"/>
              <a:t>4</a:t>
            </a:r>
            <a:r>
              <a:rPr lang="en-US" dirty="0"/>
              <a:t>Current affiliation: University of Oxford, Department of Oncology, Old road Campus Research Building, Roosevelt Drive, Oxford, OX3 7DQ. </a:t>
            </a:r>
            <a:r>
              <a:rPr lang="en-US" baseline="30000" dirty="0"/>
              <a:t>*</a:t>
            </a:r>
            <a:r>
              <a:rPr lang="en-US" dirty="0"/>
              <a:t>Co-senior author.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42498318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/>
          <p:cNvSpPr txBox="1"/>
          <p:nvPr/>
        </p:nvSpPr>
        <p:spPr>
          <a:xfrm>
            <a:off x="219944" y="6587408"/>
            <a:ext cx="650428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Supplementary </a:t>
            </a:r>
            <a:r>
              <a:rPr lang="en-US" sz="1200" b="1" dirty="0" smtClean="0"/>
              <a:t>Table </a:t>
            </a:r>
            <a:r>
              <a:rPr lang="en-US" sz="1200" b="1" dirty="0"/>
              <a:t>S1</a:t>
            </a:r>
            <a:r>
              <a:rPr lang="en-US" sz="1200" b="1" dirty="0" smtClean="0"/>
              <a:t>. </a:t>
            </a:r>
            <a:r>
              <a:rPr lang="en-US" altLang="en-US" sz="1200" b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List of antibodies used throughout experiments</a:t>
            </a:r>
            <a:r>
              <a:rPr lang="en-US" altLang="en-US" sz="1200" b="1" dirty="0" smtClean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</a:t>
            </a:r>
          </a:p>
          <a:p>
            <a:r>
              <a:rPr lang="en-US" altLang="en-US" sz="12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C – Flow cytometry; T – Therapy; IHC – immunohistochemistry; IF - </a:t>
            </a:r>
            <a:r>
              <a:rPr lang="en-US" alt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mmunofluorescence</a:t>
            </a:r>
            <a:endParaRPr lang="en-US" altLang="en-US" sz="2000" dirty="0">
              <a:latin typeface="Arial" panose="020B0604020202020204" pitchFamily="34" charset="0"/>
            </a:endParaRPr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21214327"/>
              </p:ext>
            </p:extLst>
          </p:nvPr>
        </p:nvGraphicFramePr>
        <p:xfrm>
          <a:off x="544358" y="169205"/>
          <a:ext cx="4541732" cy="6284923"/>
        </p:xfrm>
        <a:graphic>
          <a:graphicData uri="http://schemas.openxmlformats.org/drawingml/2006/table">
            <a:tbl>
              <a:tblPr firstRow="1" firstCol="1" bandRow="1"/>
              <a:tblGrid>
                <a:gridCol w="869741">
                  <a:extLst>
                    <a:ext uri="{9D8B030D-6E8A-4147-A177-3AD203B41FA5}">
                      <a16:colId xmlns:a16="http://schemas.microsoft.com/office/drawing/2014/main" val="3787069276"/>
                    </a:ext>
                  </a:extLst>
                </a:gridCol>
                <a:gridCol w="760883">
                  <a:extLst>
                    <a:ext uri="{9D8B030D-6E8A-4147-A177-3AD203B41FA5}">
                      <a16:colId xmlns:a16="http://schemas.microsoft.com/office/drawing/2014/main" val="1659634529"/>
                    </a:ext>
                  </a:extLst>
                </a:gridCol>
                <a:gridCol w="715432">
                  <a:extLst>
                    <a:ext uri="{9D8B030D-6E8A-4147-A177-3AD203B41FA5}">
                      <a16:colId xmlns:a16="http://schemas.microsoft.com/office/drawing/2014/main" val="4056884218"/>
                    </a:ext>
                  </a:extLst>
                </a:gridCol>
                <a:gridCol w="1543800">
                  <a:extLst>
                    <a:ext uri="{9D8B030D-6E8A-4147-A177-3AD203B41FA5}">
                      <a16:colId xmlns:a16="http://schemas.microsoft.com/office/drawing/2014/main" val="3448802358"/>
                    </a:ext>
                  </a:extLst>
                </a:gridCol>
                <a:gridCol w="651876">
                  <a:extLst>
                    <a:ext uri="{9D8B030D-6E8A-4147-A177-3AD203B41FA5}">
                      <a16:colId xmlns:a16="http://schemas.microsoft.com/office/drawing/2014/main" val="2158530904"/>
                    </a:ext>
                  </a:extLst>
                </a:gridCol>
              </a:tblGrid>
              <a:tr h="378609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 b="1" i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arget</a:t>
                      </a:r>
                      <a:endParaRPr lang="en-GB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 b="1" i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lone</a:t>
                      </a:r>
                      <a:endParaRPr lang="en-GB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 b="1" i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onjugate</a:t>
                      </a:r>
                      <a:endParaRPr lang="en-GB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 b="1" i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ompany</a:t>
                      </a:r>
                      <a:endParaRPr lang="en-GB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 b="1" i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pplication</a:t>
                      </a:r>
                      <a:endParaRPr lang="en-GB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52785914"/>
                  </a:ext>
                </a:extLst>
              </a:tr>
              <a:tr h="189305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D11b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1/70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E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hermo</a:t>
                      </a:r>
                      <a:r>
                        <a:rPr lang="en-GB" sz="8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Fisher - </a:t>
                      </a:r>
                      <a:r>
                        <a:rPr lang="en-GB" sz="800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Bioscience</a:t>
                      </a:r>
                      <a:endParaRPr lang="en-GB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C</a:t>
                      </a:r>
                      <a:endParaRPr lang="en-GB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25442802"/>
                  </a:ext>
                </a:extLst>
              </a:tr>
              <a:tr h="189305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Ly6G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B6-8C5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E-Cy7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hermo</a:t>
                      </a:r>
                      <a:r>
                        <a:rPr lang="en-GB" sz="8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Fisher - </a:t>
                      </a:r>
                      <a:r>
                        <a:rPr lang="en-GB" sz="800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Bioscience</a:t>
                      </a:r>
                      <a:endParaRPr lang="en-GB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C</a:t>
                      </a:r>
                      <a:endParaRPr lang="en-GB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92252825"/>
                  </a:ext>
                </a:extLst>
              </a:tr>
              <a:tr h="189305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Ly6C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HK1.4</a:t>
                      </a:r>
                      <a:endParaRPr lang="en-GB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erCP-Cy5.5</a:t>
                      </a:r>
                      <a:endParaRPr lang="en-GB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hermo</a:t>
                      </a:r>
                      <a:r>
                        <a:rPr lang="en-GB" sz="8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Fisher - </a:t>
                      </a:r>
                      <a:r>
                        <a:rPr lang="en-GB" sz="800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Bioscience</a:t>
                      </a:r>
                      <a:endParaRPr lang="en-GB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C</a:t>
                      </a:r>
                      <a:endParaRPr lang="en-GB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47922175"/>
                  </a:ext>
                </a:extLst>
              </a:tr>
              <a:tr h="189305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D11c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418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V450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hermo Fisher - eBioscience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C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77975028"/>
                  </a:ext>
                </a:extLst>
              </a:tr>
              <a:tr h="189305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D4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M4-5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ITC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hermo Fisher - eBioscience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C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74587320"/>
                  </a:ext>
                </a:extLst>
              </a:tr>
              <a:tr h="189305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D8a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3-6.7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PC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hermo Fisher - eBioscience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C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63640400"/>
                  </a:ext>
                </a:extLst>
              </a:tr>
              <a:tr h="189305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oxP3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JK16s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E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hermo Fisher - eBioscience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C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17438720"/>
                  </a:ext>
                </a:extLst>
              </a:tr>
              <a:tr h="189305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D19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D3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PC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hermo Fisher - eBioscience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C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98943836"/>
                  </a:ext>
                </a:extLst>
              </a:tr>
              <a:tr h="189305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D3e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00A2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V450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D Biosciences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C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32526189"/>
                  </a:ext>
                </a:extLst>
              </a:tr>
              <a:tr h="189305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D49b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X5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E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D Biosciences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C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6689728"/>
                  </a:ext>
                </a:extLst>
              </a:tr>
              <a:tr h="189305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H-2K b/H-2D b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8957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E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iolegend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C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71188342"/>
                  </a:ext>
                </a:extLst>
              </a:tr>
              <a:tr h="189305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220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A3-6B2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erCP-Cy5.5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iolegend</a:t>
                      </a:r>
                      <a:endParaRPr lang="en-GB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C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36287470"/>
                  </a:ext>
                </a:extLst>
              </a:tr>
              <a:tr h="39754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ouse IgG2a </a:t>
                      </a: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isotype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OPC-173</a:t>
                      </a:r>
                      <a:endParaRPr lang="en-GB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E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iolegend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C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49775587"/>
                  </a:ext>
                </a:extLst>
              </a:tr>
              <a:tr h="189305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KG2ACE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0d5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E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vus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C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65446368"/>
                  </a:ext>
                </a:extLst>
              </a:tr>
              <a:tr h="189305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4/80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l:A3-1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PC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ioRad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C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92415521"/>
                  </a:ext>
                </a:extLst>
              </a:tr>
              <a:tr h="189305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D2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4G2a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ITC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n house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C; T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98441130"/>
                  </a:ext>
                </a:extLst>
              </a:tr>
              <a:tr h="39754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ouse IgG2a </a:t>
                      </a: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isotype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K136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ITC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n house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C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18556461"/>
                  </a:ext>
                </a:extLst>
              </a:tr>
              <a:tr h="189305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cγRI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T152-9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ITC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n house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C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4276320"/>
                  </a:ext>
                </a:extLst>
              </a:tr>
              <a:tr h="189305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cγRII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T130-2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ITC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n house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C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62028121"/>
                  </a:ext>
                </a:extLst>
              </a:tr>
              <a:tr h="189305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cγRIII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T154-2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ITC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n house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C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58845552"/>
                  </a:ext>
                </a:extLst>
              </a:tr>
              <a:tr h="189305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cγRIV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9E9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ITC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n house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C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55170163"/>
                  </a:ext>
                </a:extLst>
              </a:tr>
              <a:tr h="189305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4/80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CA497BT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bD serotec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HC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50605379"/>
                  </a:ext>
                </a:extLst>
              </a:tr>
              <a:tr h="378609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D3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abbit polyclonal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bcam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HC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46332907"/>
                  </a:ext>
                </a:extLst>
              </a:tr>
              <a:tr h="189305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D45R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D Biosciences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HC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19363120"/>
                  </a:ext>
                </a:extLst>
              </a:tr>
              <a:tr h="189305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D3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hermo Fisher - Molecular probes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F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5436923"/>
                  </a:ext>
                </a:extLst>
              </a:tr>
              <a:tr h="189305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D4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hermo Fisher - Molecular probes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F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80181744"/>
                  </a:ext>
                </a:extLst>
              </a:tr>
              <a:tr h="189305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D8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hermo Fisher - Molecular probes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F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11271525"/>
                  </a:ext>
                </a:extLst>
              </a:tr>
              <a:tr h="189305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-1BB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LOB12.3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n house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</a:t>
                      </a:r>
                      <a:endParaRPr lang="en-GB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791" marR="5679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554862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37795100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/>
          <p:cNvGrpSpPr/>
          <p:nvPr/>
        </p:nvGrpSpPr>
        <p:grpSpPr>
          <a:xfrm>
            <a:off x="704918" y="143938"/>
            <a:ext cx="5338972" cy="1451490"/>
            <a:chOff x="704918" y="539552"/>
            <a:chExt cx="5338972" cy="1451490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2125" t="29000" r="34250" b="32151"/>
            <a:stretch/>
          </p:blipFill>
          <p:spPr>
            <a:xfrm>
              <a:off x="4891762" y="551710"/>
              <a:ext cx="1152128" cy="1420958"/>
            </a:xfrm>
            <a:prstGeom prst="rect">
              <a:avLst/>
            </a:prstGeom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375" t="29565" r="34977" b="30050"/>
            <a:stretch/>
          </p:blipFill>
          <p:spPr>
            <a:xfrm rot="5400000">
              <a:off x="912670" y="705657"/>
              <a:ext cx="1420957" cy="1113063"/>
            </a:xfrm>
            <a:prstGeom prst="rect">
              <a:avLst/>
            </a:prstGeom>
          </p:spPr>
        </p:pic>
        <p:pic>
          <p:nvPicPr>
            <p:cNvPr id="7" name="Picture 6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000" t="43455" r="18509" b="25045"/>
            <a:stretch/>
          </p:blipFill>
          <p:spPr>
            <a:xfrm rot="5400000">
              <a:off x="2816055" y="731471"/>
              <a:ext cx="1439332" cy="1079810"/>
            </a:xfrm>
            <a:prstGeom prst="rect">
              <a:avLst/>
            </a:prstGeom>
          </p:spPr>
        </p:pic>
        <p:sp>
          <p:nvSpPr>
            <p:cNvPr id="12" name="TextBox 11"/>
            <p:cNvSpPr txBox="1">
              <a:spLocks noChangeAspect="1"/>
            </p:cNvSpPr>
            <p:nvPr/>
          </p:nvSpPr>
          <p:spPr>
            <a:xfrm>
              <a:off x="2550342" y="540402"/>
              <a:ext cx="42388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13" name="TextBox 12"/>
            <p:cNvSpPr txBox="1">
              <a:spLocks noChangeAspect="1"/>
            </p:cNvSpPr>
            <p:nvPr/>
          </p:nvSpPr>
          <p:spPr>
            <a:xfrm>
              <a:off x="704918" y="539552"/>
              <a:ext cx="33114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14" name="TextBox 13"/>
            <p:cNvSpPr txBox="1">
              <a:spLocks noChangeAspect="1"/>
            </p:cNvSpPr>
            <p:nvPr/>
          </p:nvSpPr>
          <p:spPr>
            <a:xfrm>
              <a:off x="4467879" y="539552"/>
              <a:ext cx="42388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</p:grpSp>
      <p:sp>
        <p:nvSpPr>
          <p:cNvPr id="9" name="TextBox 8"/>
          <p:cNvSpPr txBox="1"/>
          <p:nvPr/>
        </p:nvSpPr>
        <p:spPr>
          <a:xfrm>
            <a:off x="190881" y="1962826"/>
            <a:ext cx="6504281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Supplementary Figure S1. Macroscopic structure of NXS2, 9464D and TH-MYCN tumors ex vivo. A)</a:t>
            </a:r>
            <a:r>
              <a:rPr lang="en-US" sz="1200" dirty="0"/>
              <a:t> AJ (NXS2) or </a:t>
            </a:r>
            <a:r>
              <a:rPr lang="en-US" sz="1200" b="1" dirty="0"/>
              <a:t>B)</a:t>
            </a:r>
            <a:r>
              <a:rPr lang="en-US" sz="1200" dirty="0"/>
              <a:t> C57BL/6 (9464D) were injected subcutaneously with the respective tumor cells, and tumors were harvested between 8x8 mm and 10x10 mm in size, and macroscopic structure was documented. </a:t>
            </a:r>
            <a:r>
              <a:rPr lang="en-US" sz="1200" b="1" dirty="0"/>
              <a:t>C)</a:t>
            </a:r>
            <a:r>
              <a:rPr lang="en-US" sz="1200" dirty="0"/>
              <a:t> Tumor bearing TH-MYCN mice were culled and tumors removed once palpated to be &gt;1cm, with macroscopic structure being documented. Representative images are shown.</a:t>
            </a:r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29776684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1" name="Group 20"/>
          <p:cNvGrpSpPr/>
          <p:nvPr/>
        </p:nvGrpSpPr>
        <p:grpSpPr>
          <a:xfrm>
            <a:off x="4030" y="101338"/>
            <a:ext cx="6853970" cy="5128676"/>
            <a:chOff x="123173" y="314669"/>
            <a:chExt cx="7522104" cy="5628626"/>
          </a:xfrm>
        </p:grpSpPr>
        <p:grpSp>
          <p:nvGrpSpPr>
            <p:cNvPr id="20" name="Group 19"/>
            <p:cNvGrpSpPr/>
            <p:nvPr/>
          </p:nvGrpSpPr>
          <p:grpSpPr>
            <a:xfrm>
              <a:off x="127929" y="314669"/>
              <a:ext cx="3708000" cy="2802827"/>
              <a:chOff x="3923689" y="-2590895"/>
              <a:chExt cx="3708000" cy="2802827"/>
            </a:xfrm>
          </p:grpSpPr>
          <p:pic>
            <p:nvPicPr>
              <p:cNvPr id="11" name="Picture 10"/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923689" y="-2590895"/>
                <a:ext cx="3708000" cy="2781000"/>
              </a:xfrm>
              <a:prstGeom prst="rect">
                <a:avLst/>
              </a:prstGeom>
            </p:spPr>
          </p:pic>
          <p:sp>
            <p:nvSpPr>
              <p:cNvPr id="15" name="TextBox 14"/>
              <p:cNvSpPr txBox="1"/>
              <p:nvPr/>
            </p:nvSpPr>
            <p:spPr>
              <a:xfrm>
                <a:off x="3954918" y="-193403"/>
                <a:ext cx="1065817" cy="40533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b="1" dirty="0"/>
                  <a:t>CD31</a:t>
                </a:r>
              </a:p>
            </p:txBody>
          </p:sp>
          <p:cxnSp>
            <p:nvCxnSpPr>
              <p:cNvPr id="16" name="Straight Connector 15"/>
              <p:cNvCxnSpPr/>
              <p:nvPr/>
            </p:nvCxnSpPr>
            <p:spPr>
              <a:xfrm>
                <a:off x="7042486" y="86385"/>
                <a:ext cx="414000" cy="0"/>
              </a:xfrm>
              <a:prstGeom prst="line">
                <a:avLst/>
              </a:prstGeom>
              <a:ln w="381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0" name="Group 9"/>
            <p:cNvGrpSpPr/>
            <p:nvPr/>
          </p:nvGrpSpPr>
          <p:grpSpPr>
            <a:xfrm>
              <a:off x="123173" y="323528"/>
              <a:ext cx="7522104" cy="5619767"/>
              <a:chOff x="1519198" y="419437"/>
              <a:chExt cx="7522104" cy="5619767"/>
            </a:xfrm>
          </p:grpSpPr>
          <p:pic>
            <p:nvPicPr>
              <p:cNvPr id="9" name="Picture 8"/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sharpenSoften amount="31000"/>
                        </a14:imgEffect>
                        <a14:imgEffect>
                          <a14:brightnessContrast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526245" y="3236377"/>
                <a:ext cx="3706211" cy="2784411"/>
              </a:xfrm>
              <a:prstGeom prst="rect">
                <a:avLst/>
              </a:prstGeom>
              <a:ln>
                <a:noFill/>
              </a:ln>
            </p:spPr>
          </p:pic>
          <p:pic>
            <p:nvPicPr>
              <p:cNvPr id="3" name="Picture 2"/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sharpenSoften amount="2000"/>
                        </a14:imgEffect>
                        <a14:imgEffect>
                          <a14:brightnessContrast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335091" y="3238477"/>
                <a:ext cx="3706211" cy="2779657"/>
              </a:xfrm>
              <a:prstGeom prst="rect">
                <a:avLst/>
              </a:prstGeom>
              <a:ln>
                <a:noFill/>
              </a:ln>
            </p:spPr>
          </p:pic>
          <p:sp>
            <p:nvSpPr>
              <p:cNvPr id="5" name="TextBox 4"/>
              <p:cNvSpPr txBox="1">
                <a:spLocks noChangeAspect="1"/>
              </p:cNvSpPr>
              <p:nvPr/>
            </p:nvSpPr>
            <p:spPr>
              <a:xfrm>
                <a:off x="1565568" y="419437"/>
                <a:ext cx="331145" cy="37155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</a:p>
            </p:txBody>
          </p:sp>
          <p:sp>
            <p:nvSpPr>
              <p:cNvPr id="7" name="TextBox 6"/>
              <p:cNvSpPr txBox="1"/>
              <p:nvPr/>
            </p:nvSpPr>
            <p:spPr>
              <a:xfrm>
                <a:off x="5305739" y="5633869"/>
                <a:ext cx="1326958" cy="40533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b="1" dirty="0"/>
                  <a:t>LYVE-1</a:t>
                </a:r>
              </a:p>
            </p:txBody>
          </p:sp>
          <p:sp>
            <p:nvSpPr>
              <p:cNvPr id="8" name="TextBox 7"/>
              <p:cNvSpPr txBox="1"/>
              <p:nvPr/>
            </p:nvSpPr>
            <p:spPr>
              <a:xfrm>
                <a:off x="1579156" y="5573767"/>
                <a:ext cx="1065817" cy="40533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b="1" dirty="0"/>
                  <a:t>CD31</a:t>
                </a:r>
              </a:p>
            </p:txBody>
          </p:sp>
          <p:cxnSp>
            <p:nvCxnSpPr>
              <p:cNvPr id="6" name="Straight Connector 5"/>
              <p:cNvCxnSpPr/>
              <p:nvPr/>
            </p:nvCxnSpPr>
            <p:spPr>
              <a:xfrm>
                <a:off x="4666724" y="5853555"/>
                <a:ext cx="414000" cy="0"/>
              </a:xfrm>
              <a:prstGeom prst="line">
                <a:avLst/>
              </a:prstGeom>
              <a:ln w="381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2" name="Straight Connector 11"/>
              <p:cNvCxnSpPr/>
              <p:nvPr/>
            </p:nvCxnSpPr>
            <p:spPr>
              <a:xfrm>
                <a:off x="8493619" y="5850216"/>
                <a:ext cx="414000" cy="0"/>
              </a:xfrm>
              <a:prstGeom prst="line">
                <a:avLst/>
              </a:prstGeom>
              <a:ln w="381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4" name="TextBox 3"/>
              <p:cNvSpPr txBox="1">
                <a:spLocks noChangeAspect="1"/>
              </p:cNvSpPr>
              <p:nvPr/>
            </p:nvSpPr>
            <p:spPr>
              <a:xfrm>
                <a:off x="1519198" y="3346964"/>
                <a:ext cx="423884" cy="37155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</a:p>
            </p:txBody>
          </p:sp>
        </p:grpSp>
        <p:pic>
          <p:nvPicPr>
            <p:cNvPr id="17" name="Picture 16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23689" y="314669"/>
              <a:ext cx="3708000" cy="2781000"/>
            </a:xfrm>
            <a:prstGeom prst="rect">
              <a:avLst/>
            </a:prstGeom>
          </p:spPr>
        </p:pic>
        <p:sp>
          <p:nvSpPr>
            <p:cNvPr id="18" name="TextBox 17"/>
            <p:cNvSpPr txBox="1"/>
            <p:nvPr/>
          </p:nvSpPr>
          <p:spPr>
            <a:xfrm>
              <a:off x="3909714" y="2707482"/>
              <a:ext cx="1326958" cy="4053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/>
                <a:t>LYVE-1</a:t>
              </a:r>
            </a:p>
          </p:txBody>
        </p:sp>
        <p:cxnSp>
          <p:nvCxnSpPr>
            <p:cNvPr id="19" name="Straight Connector 18"/>
            <p:cNvCxnSpPr/>
            <p:nvPr/>
          </p:nvCxnSpPr>
          <p:spPr>
            <a:xfrm>
              <a:off x="7015133" y="2947771"/>
              <a:ext cx="41400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3" name="TextBox 22"/>
          <p:cNvSpPr txBox="1"/>
          <p:nvPr/>
        </p:nvSpPr>
        <p:spPr>
          <a:xfrm>
            <a:off x="214833" y="5548212"/>
            <a:ext cx="6504281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Supplementary Figure S2. CD31 and LYVE-1 staining in frozen 9464D and TH-MYCN tumors. A) </a:t>
            </a:r>
            <a:r>
              <a:rPr lang="en-US" sz="1200" dirty="0"/>
              <a:t>9464D tumor bearing mice were culled and tumors were removed, and frozen in OCT as detailed in methods. CD31 (left panel) and LYVE-1 (right panel) IHC staining for a representative 9464D tumor. </a:t>
            </a:r>
            <a:r>
              <a:rPr lang="en-US" sz="1200" b="1" dirty="0"/>
              <a:t>B)</a:t>
            </a:r>
            <a:r>
              <a:rPr lang="en-US" sz="1200" dirty="0"/>
              <a:t> As above for CD31 (left panel) and LYVE-1 (right panel) IHC staining for ex vivo TH-MYCN tumor, showing a representative example. Scale bars, 100 µm.</a:t>
            </a:r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147921890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5" descr="\\soton.ac.uk\ude\PersonalFiles\Users\sl2e13\mydocuments\Silvia_IHC H&amp;E Raw Pics\20160408_TH-MYCN Immune panel H&amp;E IHC\20160408_TH-MYCN_R4\TH-MYCN_R4_Tumour_B220_10x_01.tif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79104" y="2373345"/>
            <a:ext cx="2880242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6" descr="\\soton.ac.uk\ude\PersonalFiles\Users\sl2e13\mydocuments\Silvia_IHC H&amp;E Raw Pics\20160408_TH-MYCN Immune panel H&amp;E IHC\20160408_TH-MYCN_R4\TH-MYCN_R4_Tumour_antiRat_10x_NKctrl.tif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sharpenSoften amount="25000"/>
                    </a14:imgEffect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79104" y="141337"/>
            <a:ext cx="2880242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Picture 7" descr="\\soton.ac.uk\ude\PersonalFiles\Users\sl2e13\mydocuments\Silvia_IHC H&amp;E Raw Pics\20160408_TH-MYCN Immune panel H&amp;E IHC\20160408_TH-MYCN_R4\TH-MYCN_R4_Tumour_CD3_10x_01.tif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sharpenSoften amount="2500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4768" y="2373345"/>
            <a:ext cx="2880242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8" name="Group 7"/>
          <p:cNvGrpSpPr/>
          <p:nvPr/>
        </p:nvGrpSpPr>
        <p:grpSpPr>
          <a:xfrm>
            <a:off x="454768" y="141097"/>
            <a:ext cx="2880242" cy="2160000"/>
            <a:chOff x="476672" y="107504"/>
            <a:chExt cx="2880242" cy="2160000"/>
          </a:xfrm>
        </p:grpSpPr>
        <p:pic>
          <p:nvPicPr>
            <p:cNvPr id="9" name="Picture 8" descr="\\soton.ac.uk\ude\PersonalFiles\Users\sl2e13\mydocuments\Silvia_IHC H&amp;E Raw Pics\20160408_TH-MYCN Immune panel H&amp;E IHC\20160408_TH-MYCN_R4\TH-MYCN_R4_Tumour_H&amp;E_10x_07.tif"/>
            <p:cNvPicPr>
              <a:picLocks noChangeAspect="1" noChangeArrowheads="1"/>
            </p:cNvPicPr>
            <p:nvPr/>
          </p:nvPicPr>
          <p:blipFill>
            <a:blip r:embed="rId9" cstate="print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76672" y="107504"/>
              <a:ext cx="2880242" cy="216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" name="TextBox 9"/>
            <p:cNvSpPr txBox="1"/>
            <p:nvPr/>
          </p:nvSpPr>
          <p:spPr>
            <a:xfrm>
              <a:off x="476672" y="107504"/>
              <a:ext cx="122413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/>
                <a:t>H&amp;E</a:t>
              </a:r>
            </a:p>
          </p:txBody>
        </p:sp>
      </p:grpSp>
      <p:sp>
        <p:nvSpPr>
          <p:cNvPr id="12" name="TextBox 11"/>
          <p:cNvSpPr txBox="1"/>
          <p:nvPr/>
        </p:nvSpPr>
        <p:spPr>
          <a:xfrm>
            <a:off x="454768" y="2394242"/>
            <a:ext cx="12241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CD3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3479104" y="2394074"/>
            <a:ext cx="12241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B220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3479104" y="141097"/>
            <a:ext cx="12241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Control</a:t>
            </a:r>
          </a:p>
        </p:txBody>
      </p:sp>
      <p:cxnSp>
        <p:nvCxnSpPr>
          <p:cNvPr id="16" name="Straight Connector 15"/>
          <p:cNvCxnSpPr/>
          <p:nvPr/>
        </p:nvCxnSpPr>
        <p:spPr>
          <a:xfrm>
            <a:off x="2759024" y="2157081"/>
            <a:ext cx="428400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>
            <a:off x="2759024" y="4389329"/>
            <a:ext cx="428400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Straight Connector 17"/>
          <p:cNvCxnSpPr/>
          <p:nvPr/>
        </p:nvCxnSpPr>
        <p:spPr>
          <a:xfrm>
            <a:off x="5787008" y="4389329"/>
            <a:ext cx="428400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" name="Straight Connector 18"/>
          <p:cNvCxnSpPr/>
          <p:nvPr/>
        </p:nvCxnSpPr>
        <p:spPr>
          <a:xfrm>
            <a:off x="5783360" y="2157081"/>
            <a:ext cx="428400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" name="TextBox 19"/>
          <p:cNvSpPr txBox="1"/>
          <p:nvPr/>
        </p:nvSpPr>
        <p:spPr>
          <a:xfrm>
            <a:off x="226963" y="4779390"/>
            <a:ext cx="6504281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Supplementary Figure S3. IHC analysis of tertiary lymphoid structures found in TH-MYCN tumors by H&amp;E, CD31 and B220 staining. </a:t>
            </a:r>
            <a:r>
              <a:rPr lang="en-US" sz="1200" dirty="0"/>
              <a:t>OCT frozen ex vivo TH-MYCN tumors were stained by various IHC techniques to identify the presence of tertiary lymphoid structures. This included (from top left, clockwise) H&amp;E, no stain control, B220 and CD3. Shown is a representative example. Scale bars, 100 µm.</a:t>
            </a:r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239049796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3"/>
          <a:srcRect r="6767"/>
          <a:stretch/>
        </p:blipFill>
        <p:spPr>
          <a:xfrm>
            <a:off x="0" y="140790"/>
            <a:ext cx="6381328" cy="5472608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200347" y="5768946"/>
            <a:ext cx="6504281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Supplementary Figure S4. Flow cytometry gating for myeloid populations. A)</a:t>
            </a:r>
            <a:r>
              <a:rPr lang="en-US" sz="1200" dirty="0"/>
              <a:t> Debris removal gate on FCS and SSC plot, live cell gating using fixable aqua (</a:t>
            </a:r>
            <a:r>
              <a:rPr lang="en-US" sz="1200" dirty="0" err="1"/>
              <a:t>amcyan</a:t>
            </a:r>
            <a:r>
              <a:rPr lang="en-US" sz="1200" dirty="0"/>
              <a:t>) and then singlet discrimination, used for all flow cytometry. </a:t>
            </a:r>
            <a:r>
              <a:rPr lang="en-US" sz="1200" b="1" dirty="0"/>
              <a:t>B)</a:t>
            </a:r>
            <a:r>
              <a:rPr lang="en-US" sz="1200" dirty="0"/>
              <a:t> Gating strategies are shown for macrophages and CD11b+ populations, with further gating on CD11b+ for neutrophils and monocytes. </a:t>
            </a:r>
            <a:r>
              <a:rPr lang="en-US" sz="1200" b="1" dirty="0"/>
              <a:t>C)</a:t>
            </a:r>
            <a:r>
              <a:rPr lang="en-US" sz="1200" dirty="0"/>
              <a:t> </a:t>
            </a:r>
            <a:r>
              <a:rPr lang="en-US" sz="1200" dirty="0" err="1"/>
              <a:t>FcγR</a:t>
            </a:r>
            <a:r>
              <a:rPr lang="en-US" sz="1200" dirty="0"/>
              <a:t> analysis the same gating was used as in B, with expression levels of </a:t>
            </a:r>
            <a:r>
              <a:rPr lang="en-US" sz="1200" dirty="0" err="1"/>
              <a:t>FcγRs</a:t>
            </a:r>
            <a:r>
              <a:rPr lang="en-US" sz="1200" dirty="0"/>
              <a:t> was assessed as MFI minus isotype control staining. Example histograms of </a:t>
            </a:r>
            <a:r>
              <a:rPr lang="en-US" sz="1200" dirty="0" err="1"/>
              <a:t>FcγRII</a:t>
            </a:r>
            <a:r>
              <a:rPr lang="en-US" sz="1200" dirty="0"/>
              <a:t> are shown. Solid grey – isotype, green – macrophage staining, blue – monocyte staining and purple – neutrophil staining. All gating strategies are shown using a representative tumor tissue sample, with spleen gating carried out in the same way minus live/dead discrimination.</a:t>
            </a:r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16243455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8" name="Picture 7"/>
          <p:cNvPicPr>
            <a:picLocks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2243" y="230074"/>
            <a:ext cx="2142000" cy="1069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0" name="Picture 10"/>
          <p:cNvPicPr>
            <a:picLocks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7178" y="1383271"/>
            <a:ext cx="2142000" cy="1069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1" name="Picture 12"/>
          <p:cNvPicPr>
            <a:picLocks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1495" y="2524078"/>
            <a:ext cx="2142000" cy="1069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8" name="TextBox 47"/>
          <p:cNvSpPr txBox="1"/>
          <p:nvPr/>
        </p:nvSpPr>
        <p:spPr>
          <a:xfrm>
            <a:off x="340208" y="1481621"/>
            <a:ext cx="353943" cy="496104"/>
          </a:xfrm>
          <a:prstGeom prst="rect">
            <a:avLst/>
          </a:prstGeom>
          <a:solidFill>
            <a:schemeClr val="bg1"/>
          </a:solidFill>
        </p:spPr>
        <p:txBody>
          <a:bodyPr vert="vert270" wrap="squar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</a:p>
        </p:txBody>
      </p:sp>
      <p:sp>
        <p:nvSpPr>
          <p:cNvPr id="18" name="TextBox 17"/>
          <p:cNvSpPr txBox="1">
            <a:spLocks/>
          </p:cNvSpPr>
          <p:nvPr/>
        </p:nvSpPr>
        <p:spPr>
          <a:xfrm rot="16200000">
            <a:off x="-119717" y="1650174"/>
            <a:ext cx="720000" cy="26161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GD2+</a:t>
            </a:r>
          </a:p>
        </p:txBody>
      </p:sp>
      <p:grpSp>
        <p:nvGrpSpPr>
          <p:cNvPr id="5" name="Group 4"/>
          <p:cNvGrpSpPr/>
          <p:nvPr/>
        </p:nvGrpSpPr>
        <p:grpSpPr>
          <a:xfrm>
            <a:off x="293216" y="3646128"/>
            <a:ext cx="2392912" cy="461665"/>
            <a:chOff x="268164" y="4542383"/>
            <a:chExt cx="2392912" cy="461665"/>
          </a:xfrm>
        </p:grpSpPr>
        <p:cxnSp>
          <p:nvCxnSpPr>
            <p:cNvPr id="46" name="Straight Connector 45"/>
            <p:cNvCxnSpPr/>
            <p:nvPr/>
          </p:nvCxnSpPr>
          <p:spPr>
            <a:xfrm>
              <a:off x="268164" y="4693742"/>
              <a:ext cx="288032" cy="0"/>
            </a:xfrm>
            <a:prstGeom prst="line">
              <a:avLst/>
            </a:prstGeom>
            <a:ln w="38100" cmpd="sng"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Straight Connector 46"/>
            <p:cNvCxnSpPr/>
            <p:nvPr/>
          </p:nvCxnSpPr>
          <p:spPr>
            <a:xfrm>
              <a:off x="1567443" y="4701940"/>
              <a:ext cx="288032" cy="0"/>
            </a:xfrm>
            <a:prstGeom prst="line">
              <a:avLst/>
            </a:prstGeom>
            <a:ln w="38100">
              <a:solidFill>
                <a:schemeClr val="tx1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TextBox 49"/>
            <p:cNvSpPr txBox="1"/>
            <p:nvPr/>
          </p:nvSpPr>
          <p:spPr>
            <a:xfrm>
              <a:off x="564208" y="4542383"/>
              <a:ext cx="931361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Isotype control</a:t>
              </a:r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1863487" y="4563440"/>
              <a:ext cx="79758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Antibody</a:t>
              </a:r>
            </a:p>
          </p:txBody>
        </p:sp>
      </p:grpSp>
      <p:sp>
        <p:nvSpPr>
          <p:cNvPr id="24" name="TextBox 23"/>
          <p:cNvSpPr txBox="1"/>
          <p:nvPr/>
        </p:nvSpPr>
        <p:spPr>
          <a:xfrm>
            <a:off x="753085" y="0"/>
            <a:ext cx="19686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9464D spleen</a:t>
            </a:r>
          </a:p>
        </p:txBody>
      </p:sp>
      <p:sp>
        <p:nvSpPr>
          <p:cNvPr id="49" name="TextBox 48"/>
          <p:cNvSpPr txBox="1"/>
          <p:nvPr/>
        </p:nvSpPr>
        <p:spPr>
          <a:xfrm>
            <a:off x="322328" y="2602412"/>
            <a:ext cx="353943" cy="496104"/>
          </a:xfrm>
          <a:prstGeom prst="rect">
            <a:avLst/>
          </a:prstGeom>
          <a:solidFill>
            <a:schemeClr val="bg1"/>
          </a:solidFill>
        </p:spPr>
        <p:txBody>
          <a:bodyPr vert="vert270" wrap="squar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2327" y="289746"/>
            <a:ext cx="353943" cy="496104"/>
          </a:xfrm>
          <a:prstGeom prst="rect">
            <a:avLst/>
          </a:prstGeom>
          <a:solidFill>
            <a:schemeClr val="bg1"/>
          </a:solidFill>
        </p:spPr>
        <p:txBody>
          <a:bodyPr vert="vert270" wrap="squar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</a:p>
        </p:txBody>
      </p:sp>
      <p:sp>
        <p:nvSpPr>
          <p:cNvPr id="32" name="TextBox 31"/>
          <p:cNvSpPr txBox="1">
            <a:spLocks/>
          </p:cNvSpPr>
          <p:nvPr/>
        </p:nvSpPr>
        <p:spPr>
          <a:xfrm rot="16200000">
            <a:off x="-119717" y="2794231"/>
            <a:ext cx="720000" cy="26161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GD2-</a:t>
            </a:r>
          </a:p>
        </p:txBody>
      </p:sp>
      <p:sp>
        <p:nvSpPr>
          <p:cNvPr id="55" name="TextBox 54"/>
          <p:cNvSpPr txBox="1">
            <a:spLocks/>
          </p:cNvSpPr>
          <p:nvPr/>
        </p:nvSpPr>
        <p:spPr>
          <a:xfrm>
            <a:off x="1436299" y="1128423"/>
            <a:ext cx="565449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GD2</a:t>
            </a:r>
          </a:p>
        </p:txBody>
      </p:sp>
      <p:sp>
        <p:nvSpPr>
          <p:cNvPr id="56" name="TextBox 55"/>
          <p:cNvSpPr txBox="1">
            <a:spLocks/>
          </p:cNvSpPr>
          <p:nvPr/>
        </p:nvSpPr>
        <p:spPr>
          <a:xfrm>
            <a:off x="1142959" y="2280551"/>
            <a:ext cx="1152128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MHC class I</a:t>
            </a:r>
          </a:p>
        </p:txBody>
      </p:sp>
      <p:sp>
        <p:nvSpPr>
          <p:cNvPr id="57" name="TextBox 56"/>
          <p:cNvSpPr txBox="1">
            <a:spLocks/>
          </p:cNvSpPr>
          <p:nvPr/>
        </p:nvSpPr>
        <p:spPr>
          <a:xfrm>
            <a:off x="1146986" y="3438570"/>
            <a:ext cx="1152128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MHC class I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109478" y="4181700"/>
            <a:ext cx="6504281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Supplementary Figure S5. Expression of MHC I on GD2</a:t>
            </a:r>
            <a:r>
              <a:rPr lang="en-US" sz="1200" b="1" baseline="30000" dirty="0"/>
              <a:t>-</a:t>
            </a:r>
            <a:r>
              <a:rPr lang="en-US" sz="1200" b="1" dirty="0"/>
              <a:t> cells in spleens of 9464D mice. </a:t>
            </a:r>
            <a:r>
              <a:rPr lang="en-US" sz="1200" dirty="0"/>
              <a:t>Spleens were disaggregated and stained for flow cytometry analysis. Gating used as shown in </a:t>
            </a:r>
            <a:r>
              <a:rPr lang="en-GB" sz="1200" dirty="0"/>
              <a:t>Supplementary Fig S</a:t>
            </a:r>
            <a:r>
              <a:rPr lang="en-US" sz="1200" dirty="0"/>
              <a:t>4. Representative histograms of GD2 and MHC I expression on spleens of 9464D tumor bearing mice. Expression of MHC I is shown on both GD2</a:t>
            </a:r>
            <a:r>
              <a:rPr lang="en-US" sz="1200" baseline="30000" dirty="0"/>
              <a:t>+</a:t>
            </a:r>
            <a:r>
              <a:rPr lang="en-US" sz="1200" dirty="0"/>
              <a:t> and GD2</a:t>
            </a:r>
            <a:r>
              <a:rPr lang="en-US" sz="1200" baseline="30000" dirty="0"/>
              <a:t>-</a:t>
            </a:r>
            <a:r>
              <a:rPr lang="en-US" sz="1200" dirty="0"/>
              <a:t> cells. Grey - isotype control; black line – anti-GD2 or MHC I antibody, as stated.</a:t>
            </a:r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314774198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0"/>
            <a:ext cx="6716358" cy="8742016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0" y="8705671"/>
            <a:ext cx="6751962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Supplementary Figure S6. Flow cytometry gating for lymphocyte populations. </a:t>
            </a:r>
            <a:r>
              <a:rPr lang="en-GB" sz="1200" b="1" dirty="0"/>
              <a:t>A) </a:t>
            </a:r>
            <a:r>
              <a:rPr lang="en-GB" sz="1200" dirty="0"/>
              <a:t>Debris removal gate on FCS and SSC plot, live cell gating using fixable aqua (</a:t>
            </a:r>
            <a:r>
              <a:rPr lang="en-GB" sz="1200" dirty="0" err="1"/>
              <a:t>amcyan</a:t>
            </a:r>
            <a:r>
              <a:rPr lang="en-GB" sz="1200" dirty="0"/>
              <a:t>), singlet discrimination and finally lymphocyte gating back on FCS SSC plot, as used for all lymphocyte flow cytometry. </a:t>
            </a:r>
            <a:r>
              <a:rPr lang="en-GB" sz="1200" b="1" dirty="0"/>
              <a:t>B)</a:t>
            </a:r>
            <a:r>
              <a:rPr lang="en-GB" sz="1200" dirty="0"/>
              <a:t> Gating strategies are shown for NK. </a:t>
            </a:r>
            <a:r>
              <a:rPr lang="en-GB" sz="1200" b="1" dirty="0"/>
              <a:t>C)</a:t>
            </a:r>
            <a:r>
              <a:rPr lang="en-GB" sz="1200" dirty="0"/>
              <a:t> Gating of CD3</a:t>
            </a:r>
            <a:r>
              <a:rPr lang="en-GB" sz="1200" baseline="30000" dirty="0"/>
              <a:t>+</a:t>
            </a:r>
            <a:r>
              <a:rPr lang="en-GB" sz="1200" dirty="0"/>
              <a:t> and CD3</a:t>
            </a:r>
            <a:r>
              <a:rPr lang="en-GB" sz="1200" baseline="30000" dirty="0"/>
              <a:t>-</a:t>
            </a:r>
            <a:r>
              <a:rPr lang="en-GB" sz="1200" dirty="0"/>
              <a:t> populations, followed by B cell population gating. </a:t>
            </a:r>
            <a:r>
              <a:rPr lang="en-GB" sz="1200" b="1" dirty="0"/>
              <a:t>D)</a:t>
            </a:r>
            <a:r>
              <a:rPr lang="en-GB" sz="1200" dirty="0"/>
              <a:t> CD4</a:t>
            </a:r>
            <a:r>
              <a:rPr lang="en-GB" sz="1200" baseline="30000" dirty="0"/>
              <a:t>+</a:t>
            </a:r>
            <a:r>
              <a:rPr lang="en-GB" sz="1200" dirty="0"/>
              <a:t>, CD8</a:t>
            </a:r>
            <a:r>
              <a:rPr lang="en-GB" sz="1200" baseline="30000" dirty="0"/>
              <a:t>+</a:t>
            </a:r>
            <a:r>
              <a:rPr lang="en-GB" sz="1200" dirty="0"/>
              <a:t> and FoxP3</a:t>
            </a:r>
            <a:r>
              <a:rPr lang="en-GB" sz="1200" baseline="30000" dirty="0"/>
              <a:t>+</a:t>
            </a:r>
            <a:r>
              <a:rPr lang="en-GB" sz="1200" dirty="0"/>
              <a:t> gates are shown. All gating strategies are shown using a representative </a:t>
            </a:r>
            <a:r>
              <a:rPr lang="en-GB" sz="1200" dirty="0" err="1"/>
              <a:t>tumor</a:t>
            </a:r>
            <a:r>
              <a:rPr lang="en-GB" sz="1200" dirty="0"/>
              <a:t> tissue sample, with spleen gating carried out in the same way minus live/dead discrimination.</a:t>
            </a:r>
          </a:p>
        </p:txBody>
      </p:sp>
    </p:spTree>
    <p:extLst>
      <p:ext uri="{BB962C8B-B14F-4D97-AF65-F5344CB8AC3E}">
        <p14:creationId xmlns:p14="http://schemas.microsoft.com/office/powerpoint/2010/main" val="65060293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4</TotalTime>
  <Words>1057</Words>
  <Application>Microsoft Office PowerPoint</Application>
  <PresentationFormat>A4 Paper (210x297 mm)</PresentationFormat>
  <Paragraphs>197</Paragraphs>
  <Slides>8</Slides>
  <Notes>8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3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Edinburg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EBB Emily</dc:creator>
  <cp:lastModifiedBy>Emily Webb</cp:lastModifiedBy>
  <cp:revision>7</cp:revision>
  <cp:lastPrinted>2019-11-12T16:37:47Z</cp:lastPrinted>
  <dcterms:created xsi:type="dcterms:W3CDTF">2019-11-12T15:53:53Z</dcterms:created>
  <dcterms:modified xsi:type="dcterms:W3CDTF">2020-07-01T08:27:30Z</dcterms:modified>
</cp:coreProperties>
</file>